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4" d="100"/>
          <a:sy n="54" d="100"/>
        </p:scale>
        <p:origin x="66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E860A-0F1E-4110-AD25-FE73AC7D14E2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D2909-9360-481D-9C53-805A59D23E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3211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E860A-0F1E-4110-AD25-FE73AC7D14E2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D2909-9360-481D-9C53-805A59D23E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2188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E860A-0F1E-4110-AD25-FE73AC7D14E2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D2909-9360-481D-9C53-805A59D23E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7293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E860A-0F1E-4110-AD25-FE73AC7D14E2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D2909-9360-481D-9C53-805A59D23E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8108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E860A-0F1E-4110-AD25-FE73AC7D14E2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D2909-9360-481D-9C53-805A59D23E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6301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E860A-0F1E-4110-AD25-FE73AC7D14E2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D2909-9360-481D-9C53-805A59D23E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3588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E860A-0F1E-4110-AD25-FE73AC7D14E2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D2909-9360-481D-9C53-805A59D23E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0564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E860A-0F1E-4110-AD25-FE73AC7D14E2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D2909-9360-481D-9C53-805A59D23E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17987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E860A-0F1E-4110-AD25-FE73AC7D14E2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D2909-9360-481D-9C53-805A59D23E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5519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E860A-0F1E-4110-AD25-FE73AC7D14E2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D2909-9360-481D-9C53-805A59D23E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930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E860A-0F1E-4110-AD25-FE73AC7D14E2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D2909-9360-481D-9C53-805A59D23E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9465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4E860A-0F1E-4110-AD25-FE73AC7D14E2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D2909-9360-481D-9C53-805A59D23E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3501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1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2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3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4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5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6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6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ure 1B</a:t>
            </a:r>
            <a:endParaRPr lang="zh-CN" altLang="en-US" dirty="0"/>
          </a:p>
        </p:txBody>
      </p:sp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2049543"/>
              </p:ext>
            </p:extLst>
          </p:nvPr>
        </p:nvGraphicFramePr>
        <p:xfrm>
          <a:off x="1515819" y="2402132"/>
          <a:ext cx="9884358" cy="28380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工作表" r:id="rId3" imgW="4810233" imgH="1381091" progId="Excel.Sheet.12">
                  <p:embed/>
                </p:oleObj>
              </mc:Choice>
              <mc:Fallback>
                <p:oleObj name="工作表" r:id="rId3" imgW="4810233" imgH="1381091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15819" y="2402132"/>
                        <a:ext cx="9884358" cy="28380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567758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ure 3A</a:t>
            </a:r>
            <a:endParaRPr lang="zh-CN" altLang="en-US" dirty="0"/>
          </a:p>
        </p:txBody>
      </p:sp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2458502"/>
              </p:ext>
            </p:extLst>
          </p:nvPr>
        </p:nvGraphicFramePr>
        <p:xfrm>
          <a:off x="1375630" y="1498600"/>
          <a:ext cx="6867525" cy="1552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工作表" r:id="rId3" imgW="6867480" imgH="1552541" progId="Excel.Sheet.12">
                  <p:embed/>
                </p:oleObj>
              </mc:Choice>
              <mc:Fallback>
                <p:oleObj name="工作表" r:id="rId3" imgW="6867480" imgH="1552541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75630" y="1498600"/>
                        <a:ext cx="6867525" cy="1552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418981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ure 3B</a:t>
            </a:r>
            <a:endParaRPr lang="zh-CN" altLang="en-US" dirty="0"/>
          </a:p>
        </p:txBody>
      </p:sp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1446615"/>
              </p:ext>
            </p:extLst>
          </p:nvPr>
        </p:nvGraphicFramePr>
        <p:xfrm>
          <a:off x="602517" y="1690688"/>
          <a:ext cx="10382677" cy="24768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工作表" r:id="rId3" imgW="6867480" imgH="1638266" progId="Excel.Sheet.12">
                  <p:embed/>
                </p:oleObj>
              </mc:Choice>
              <mc:Fallback>
                <p:oleObj name="工作表" r:id="rId3" imgW="6867480" imgH="1638266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02517" y="1690688"/>
                        <a:ext cx="10382677" cy="24768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562453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ure 3C</a:t>
            </a:r>
            <a:endParaRPr lang="zh-CN" altLang="en-US" dirty="0"/>
          </a:p>
        </p:txBody>
      </p:sp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0384909"/>
              </p:ext>
            </p:extLst>
          </p:nvPr>
        </p:nvGraphicFramePr>
        <p:xfrm>
          <a:off x="838200" y="2078404"/>
          <a:ext cx="10874392" cy="24584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工作表" r:id="rId3" imgW="6867480" imgH="1552541" progId="Excel.Sheet.12">
                  <p:embed/>
                </p:oleObj>
              </mc:Choice>
              <mc:Fallback>
                <p:oleObj name="工作表" r:id="rId3" imgW="6867480" imgH="1552541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38200" y="2078404"/>
                        <a:ext cx="10874392" cy="24584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754630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ure 6A</a:t>
            </a:r>
            <a:endParaRPr lang="zh-CN" altLang="en-US" dirty="0"/>
          </a:p>
        </p:txBody>
      </p:sp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1827522"/>
              </p:ext>
            </p:extLst>
          </p:nvPr>
        </p:nvGraphicFramePr>
        <p:xfrm>
          <a:off x="838200" y="2008554"/>
          <a:ext cx="10720054" cy="18073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2" name="工作表" r:id="rId3" imgW="4124280" imgH="695291" progId="Excel.Sheet.12">
                  <p:embed/>
                </p:oleObj>
              </mc:Choice>
              <mc:Fallback>
                <p:oleObj name="工作表" r:id="rId3" imgW="4124280" imgH="695291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38200" y="2008554"/>
                        <a:ext cx="10720054" cy="18073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559228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ure 6B</a:t>
            </a:r>
            <a:endParaRPr lang="zh-CN" altLang="en-US" dirty="0"/>
          </a:p>
        </p:txBody>
      </p:sp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1267611"/>
              </p:ext>
            </p:extLst>
          </p:nvPr>
        </p:nvGraphicFramePr>
        <p:xfrm>
          <a:off x="1125415" y="2237886"/>
          <a:ext cx="8421043" cy="14197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6" name="工作表" r:id="rId3" imgW="4124280" imgH="695291" progId="Excel.Sheet.12">
                  <p:embed/>
                </p:oleObj>
              </mc:Choice>
              <mc:Fallback>
                <p:oleObj name="工作表" r:id="rId3" imgW="4124280" imgH="695291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25415" y="2237886"/>
                        <a:ext cx="8421043" cy="14197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622054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ure 6C  a-</a:t>
            </a:r>
            <a:r>
              <a:rPr lang="en-US" altLang="zh-CN" dirty="0" err="1" smtClean="0"/>
              <a:t>sma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5927" y="597158"/>
            <a:ext cx="2981992" cy="4100239"/>
          </a:xfrm>
        </p:spPr>
      </p:pic>
    </p:spTree>
    <p:extLst>
      <p:ext uri="{BB962C8B-B14F-4D97-AF65-F5344CB8AC3E}">
        <p14:creationId xmlns:p14="http://schemas.microsoft.com/office/powerpoint/2010/main" val="10894523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ure 6C collagen-1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6096000" y="579574"/>
            <a:ext cx="2981992" cy="4100239"/>
          </a:xfrm>
        </p:spPr>
      </p:pic>
    </p:spTree>
    <p:extLst>
      <p:ext uri="{BB962C8B-B14F-4D97-AF65-F5344CB8AC3E}">
        <p14:creationId xmlns:p14="http://schemas.microsoft.com/office/powerpoint/2010/main" val="164620059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a</a:t>
            </a:r>
            <a:r>
              <a:rPr lang="en-US" altLang="zh-CN" dirty="0" smtClean="0"/>
              <a:t>-</a:t>
            </a:r>
            <a:r>
              <a:rPr lang="en-US" altLang="zh-CN" dirty="0" err="1" smtClean="0"/>
              <a:t>tublin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6220" y="1690688"/>
            <a:ext cx="2981992" cy="4100239"/>
          </a:xfrm>
        </p:spPr>
      </p:pic>
    </p:spTree>
    <p:extLst>
      <p:ext uri="{BB962C8B-B14F-4D97-AF65-F5344CB8AC3E}">
        <p14:creationId xmlns:p14="http://schemas.microsoft.com/office/powerpoint/2010/main" val="4098462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9</Words>
  <Application>Microsoft Office PowerPoint</Application>
  <PresentationFormat>宽屏</PresentationFormat>
  <Paragraphs>9</Paragraphs>
  <Slides>9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5" baseType="lpstr">
      <vt:lpstr>宋体</vt:lpstr>
      <vt:lpstr>Arial</vt:lpstr>
      <vt:lpstr>Calibri</vt:lpstr>
      <vt:lpstr>Calibri Light</vt:lpstr>
      <vt:lpstr>Office 主题</vt:lpstr>
      <vt:lpstr>Microsoft Excel 工作表</vt:lpstr>
      <vt:lpstr>Figure 1B</vt:lpstr>
      <vt:lpstr>Figure 3A</vt:lpstr>
      <vt:lpstr>Figure 3B</vt:lpstr>
      <vt:lpstr>Figure 3C</vt:lpstr>
      <vt:lpstr>Figure 6A</vt:lpstr>
      <vt:lpstr>Figure 6B</vt:lpstr>
      <vt:lpstr>Figure 6C  a-sma</vt:lpstr>
      <vt:lpstr>Figure 6C collagen-1</vt:lpstr>
      <vt:lpstr>a-tubli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B</dc:title>
  <dc:creator>Microsoft 帐户</dc:creator>
  <cp:lastModifiedBy>Microsoft 帐户</cp:lastModifiedBy>
  <cp:revision>1</cp:revision>
  <dcterms:created xsi:type="dcterms:W3CDTF">2022-05-18T08:44:16Z</dcterms:created>
  <dcterms:modified xsi:type="dcterms:W3CDTF">2022-05-18T08:49:43Z</dcterms:modified>
</cp:coreProperties>
</file>